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11887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1" d="100"/>
          <a:sy n="61" d="100"/>
        </p:scale>
        <p:origin x="61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5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16:$G$19</c:f>
                <c:numCache>
                  <c:formatCode>General</c:formatCode>
                  <c:ptCount val="4"/>
                  <c:pt idx="0">
                    <c:v>5.8727229164279997</c:v>
                  </c:pt>
                  <c:pt idx="1">
                    <c:v>11.639080306087299</c:v>
                  </c:pt>
                  <c:pt idx="2">
                    <c:v>5.4560243035999996</c:v>
                  </c:pt>
                  <c:pt idx="3">
                    <c:v>6.5405112919899997</c:v>
                  </c:pt>
                </c:numCache>
              </c:numRef>
            </c:plus>
            <c:minus>
              <c:numRef>
                <c:f>Sheet1!$G$16:$G$19</c:f>
                <c:numCache>
                  <c:formatCode>General</c:formatCode>
                  <c:ptCount val="4"/>
                  <c:pt idx="0">
                    <c:v>5.8727229164279997</c:v>
                  </c:pt>
                  <c:pt idx="1">
                    <c:v>11.639080306087299</c:v>
                  </c:pt>
                  <c:pt idx="2">
                    <c:v>5.4560243035999996</c:v>
                  </c:pt>
                  <c:pt idx="3">
                    <c:v>6.5405112919899997</c:v>
                  </c:pt>
                </c:numCache>
              </c:numRef>
            </c:minus>
          </c:errBars>
          <c:cat>
            <c:strRef>
              <c:f>Sheet1!$B$16:$B$19</c:f>
              <c:strCache>
                <c:ptCount val="4"/>
                <c:pt idx="0">
                  <c:v>Rott 50 </c:v>
                </c:pt>
                <c:pt idx="1">
                  <c:v>Rott 25</c:v>
                </c:pt>
                <c:pt idx="2">
                  <c:v>Rott 12.5</c:v>
                </c:pt>
                <c:pt idx="3">
                  <c:v>Rott 6.25</c:v>
                </c:pt>
              </c:strCache>
            </c:strRef>
          </c:cat>
          <c:val>
            <c:numRef>
              <c:f>Sheet1!$C$16:$C$19</c:f>
              <c:numCache>
                <c:formatCode>General</c:formatCode>
                <c:ptCount val="4"/>
                <c:pt idx="0">
                  <c:v>23.35216572504708</c:v>
                </c:pt>
                <c:pt idx="1">
                  <c:v>64.783427495291903</c:v>
                </c:pt>
                <c:pt idx="2">
                  <c:v>92.467043314500941</c:v>
                </c:pt>
                <c:pt idx="3">
                  <c:v>103.747645951035</c:v>
                </c:pt>
              </c:numCache>
            </c:numRef>
          </c:val>
        </c:ser>
        <c:ser>
          <c:idx val="1"/>
          <c:order val="1"/>
          <c:tx>
            <c:strRef>
              <c:f>Sheet1!$D$15</c:f>
              <c:strCache>
                <c:ptCount val="1"/>
                <c:pt idx="0">
                  <c:v>P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16:$H$19</c:f>
                <c:numCache>
                  <c:formatCode>General</c:formatCode>
                  <c:ptCount val="4"/>
                  <c:pt idx="0">
                    <c:v>6.0786490777255997</c:v>
                  </c:pt>
                  <c:pt idx="1">
                    <c:v>7.37785739</c:v>
                  </c:pt>
                  <c:pt idx="2">
                    <c:v>8.4377704918030005</c:v>
                  </c:pt>
                  <c:pt idx="3">
                    <c:v>7.9043211498337698</c:v>
                  </c:pt>
                </c:numCache>
              </c:numRef>
            </c:plus>
            <c:minus>
              <c:numRef>
                <c:f>Sheet1!$H$16:$H$19</c:f>
                <c:numCache>
                  <c:formatCode>General</c:formatCode>
                  <c:ptCount val="4"/>
                  <c:pt idx="0">
                    <c:v>6.0786490777255997</c:v>
                  </c:pt>
                  <c:pt idx="1">
                    <c:v>7.37785739</c:v>
                  </c:pt>
                  <c:pt idx="2">
                    <c:v>8.4377704918030005</c:v>
                  </c:pt>
                  <c:pt idx="3">
                    <c:v>7.9043211498337698</c:v>
                  </c:pt>
                </c:numCache>
              </c:numRef>
            </c:minus>
          </c:errBars>
          <c:cat>
            <c:strRef>
              <c:f>Sheet1!$B$16:$B$19</c:f>
              <c:strCache>
                <c:ptCount val="4"/>
                <c:pt idx="0">
                  <c:v>Rott 50 </c:v>
                </c:pt>
                <c:pt idx="1">
                  <c:v>Rott 25</c:v>
                </c:pt>
                <c:pt idx="2">
                  <c:v>Rott 12.5</c:v>
                </c:pt>
                <c:pt idx="3">
                  <c:v>Rott 6.25</c:v>
                </c:pt>
              </c:strCache>
            </c:strRef>
          </c:cat>
          <c:val>
            <c:numRef>
              <c:f>Sheet1!$D$16:$D$19</c:f>
              <c:numCache>
                <c:formatCode>General</c:formatCode>
                <c:ptCount val="4"/>
                <c:pt idx="0">
                  <c:v>72.473867595818817</c:v>
                </c:pt>
                <c:pt idx="1">
                  <c:v>92.682926829268297</c:v>
                </c:pt>
                <c:pt idx="2">
                  <c:v>97.909407665505228</c:v>
                </c:pt>
                <c:pt idx="3">
                  <c:v>99.1869918699187</c:v>
                </c:pt>
              </c:numCache>
            </c:numRef>
          </c:val>
        </c:ser>
        <c:ser>
          <c:idx val="2"/>
          <c:order val="2"/>
          <c:tx>
            <c:strRef>
              <c:f>Sheet1!$E$15</c:f>
              <c:strCache>
                <c:ptCount val="1"/>
                <c:pt idx="0">
                  <c:v>T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16:$I$19</c:f>
                <c:numCache>
                  <c:formatCode>General</c:formatCode>
                  <c:ptCount val="4"/>
                  <c:pt idx="0">
                    <c:v>4.7106500059999998</c:v>
                  </c:pt>
                  <c:pt idx="1">
                    <c:v>8.4277864266999991</c:v>
                  </c:pt>
                  <c:pt idx="2">
                    <c:v>7.4931842100079997</c:v>
                  </c:pt>
                  <c:pt idx="3">
                    <c:v>4.9381423822080004</c:v>
                  </c:pt>
                </c:numCache>
              </c:numRef>
            </c:plus>
            <c:minus>
              <c:numRef>
                <c:f>Sheet1!$I$16:$I$19</c:f>
                <c:numCache>
                  <c:formatCode>General</c:formatCode>
                  <c:ptCount val="4"/>
                  <c:pt idx="0">
                    <c:v>4.7106500059999998</c:v>
                  </c:pt>
                  <c:pt idx="1">
                    <c:v>8.4277864266999991</c:v>
                  </c:pt>
                  <c:pt idx="2">
                    <c:v>7.4931842100079997</c:v>
                  </c:pt>
                  <c:pt idx="3">
                    <c:v>4.9381423822080004</c:v>
                  </c:pt>
                </c:numCache>
              </c:numRef>
            </c:minus>
          </c:errBars>
          <c:cat>
            <c:strRef>
              <c:f>Sheet1!$B$16:$B$19</c:f>
              <c:strCache>
                <c:ptCount val="4"/>
                <c:pt idx="0">
                  <c:v>Rott 50 </c:v>
                </c:pt>
                <c:pt idx="1">
                  <c:v>Rott 25</c:v>
                </c:pt>
                <c:pt idx="2">
                  <c:v>Rott 12.5</c:v>
                </c:pt>
                <c:pt idx="3">
                  <c:v>Rott 6.25</c:v>
                </c:pt>
              </c:strCache>
            </c:strRef>
          </c:cat>
          <c:val>
            <c:numRef>
              <c:f>Sheet1!$E$16:$E$19</c:f>
              <c:numCache>
                <c:formatCode>General</c:formatCode>
                <c:ptCount val="4"/>
                <c:pt idx="0">
                  <c:v>47.597254004576648</c:v>
                </c:pt>
                <c:pt idx="1">
                  <c:v>94.73684210526315</c:v>
                </c:pt>
                <c:pt idx="2">
                  <c:v>98.077803203661006</c:v>
                </c:pt>
                <c:pt idx="3">
                  <c:v>107.5972540045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8544008"/>
        <c:axId val="191280552"/>
      </c:barChart>
      <c:catAx>
        <c:axId val="14854400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91280552"/>
        <c:crosses val="autoZero"/>
        <c:auto val="1"/>
        <c:lblAlgn val="ctr"/>
        <c:lblOffset val="100"/>
        <c:noMultiLvlLbl val="0"/>
      </c:catAx>
      <c:valAx>
        <c:axId val="191280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48544008"/>
        <c:crosses val="autoZero"/>
        <c:crossBetween val="between"/>
        <c:majorUnit val="30"/>
      </c:valAx>
      <c:spPr>
        <a:ln w="3810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3:$G$6</c:f>
                <c:numCache>
                  <c:formatCode>General</c:formatCode>
                  <c:ptCount val="4"/>
                  <c:pt idx="0">
                    <c:v>6.4762016621621603</c:v>
                  </c:pt>
                  <c:pt idx="1">
                    <c:v>3.4891891891890001</c:v>
                  </c:pt>
                  <c:pt idx="2">
                    <c:v>2.43243243</c:v>
                  </c:pt>
                  <c:pt idx="3">
                    <c:v>7.6842430000000004</c:v>
                  </c:pt>
                </c:numCache>
              </c:numRef>
            </c:plus>
            <c:minus>
              <c:numRef>
                <c:f>Sheet1!$G$3:$G$6</c:f>
                <c:numCache>
                  <c:formatCode>General</c:formatCode>
                  <c:ptCount val="4"/>
                  <c:pt idx="0">
                    <c:v>6.4762016621621603</c:v>
                  </c:pt>
                  <c:pt idx="1">
                    <c:v>3.4891891891890001</c:v>
                  </c:pt>
                  <c:pt idx="2">
                    <c:v>2.43243243</c:v>
                  </c:pt>
                  <c:pt idx="3">
                    <c:v>7.6842430000000004</c:v>
                  </c:pt>
                </c:numCache>
              </c:numRef>
            </c:minus>
          </c:errBars>
          <c:cat>
            <c:strRef>
              <c:f>Sheet1!$B$3:$B$6</c:f>
              <c:strCache>
                <c:ptCount val="4"/>
                <c:pt idx="0">
                  <c:v>WP5</c:v>
                </c:pt>
                <c:pt idx="1">
                  <c:v>Wp2.5</c:v>
                </c:pt>
                <c:pt idx="2">
                  <c:v>WP1.25</c:v>
                </c:pt>
                <c:pt idx="3">
                  <c:v>WP0.625</c:v>
                </c:pt>
              </c:strCache>
            </c:strRef>
          </c:cat>
          <c:val>
            <c:numRef>
              <c:f>Sheet1!$C$3:$C$6</c:f>
              <c:numCache>
                <c:formatCode>General</c:formatCode>
                <c:ptCount val="4"/>
                <c:pt idx="0">
                  <c:v>-6.0263653483992474</c:v>
                </c:pt>
                <c:pt idx="1">
                  <c:v>-7.1939736346516012</c:v>
                </c:pt>
                <c:pt idx="2">
                  <c:v>91.337099811676083</c:v>
                </c:pt>
                <c:pt idx="3">
                  <c:v>98.681732580037661</c:v>
                </c:pt>
              </c:numCache>
            </c:numRef>
          </c:val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P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3:$H$6</c:f>
                <c:numCache>
                  <c:formatCode>General</c:formatCode>
                  <c:ptCount val="4"/>
                  <c:pt idx="0">
                    <c:v>1.9674756</c:v>
                  </c:pt>
                  <c:pt idx="1">
                    <c:v>1.84876615746096</c:v>
                  </c:pt>
                  <c:pt idx="2">
                    <c:v>8.6163150999999996</c:v>
                  </c:pt>
                  <c:pt idx="3">
                    <c:v>8.6756756999999993</c:v>
                  </c:pt>
                </c:numCache>
              </c:numRef>
            </c:plus>
            <c:minus>
              <c:numRef>
                <c:f>Sheet1!$H$3:$H$6</c:f>
                <c:numCache>
                  <c:formatCode>General</c:formatCode>
                  <c:ptCount val="4"/>
                  <c:pt idx="0">
                    <c:v>1.9674756</c:v>
                  </c:pt>
                  <c:pt idx="1">
                    <c:v>1.84876615746096</c:v>
                  </c:pt>
                  <c:pt idx="2">
                    <c:v>8.6163150999999996</c:v>
                  </c:pt>
                  <c:pt idx="3">
                    <c:v>8.6756756999999993</c:v>
                  </c:pt>
                </c:numCache>
              </c:numRef>
            </c:minus>
          </c:errBars>
          <c:cat>
            <c:strRef>
              <c:f>Sheet1!$B$3:$B$6</c:f>
              <c:strCache>
                <c:ptCount val="4"/>
                <c:pt idx="0">
                  <c:v>WP5</c:v>
                </c:pt>
                <c:pt idx="1">
                  <c:v>Wp2.5</c:v>
                </c:pt>
                <c:pt idx="2">
                  <c:v>WP1.25</c:v>
                </c:pt>
                <c:pt idx="3">
                  <c:v>WP0.625</c:v>
                </c:pt>
              </c:strCache>
            </c:strRef>
          </c:cat>
          <c:val>
            <c:numRef>
              <c:f>Sheet1!$D$3:$D$6</c:f>
              <c:numCache>
                <c:formatCode>General</c:formatCode>
                <c:ptCount val="4"/>
                <c:pt idx="0">
                  <c:v>-3.9140534262485485</c:v>
                </c:pt>
                <c:pt idx="1">
                  <c:v>-5.5632984901277593</c:v>
                </c:pt>
                <c:pt idx="2">
                  <c:v>64.111498257839713</c:v>
                </c:pt>
                <c:pt idx="3">
                  <c:v>95.470383275261312</c:v>
                </c:pt>
              </c:numCache>
            </c:numRef>
          </c:val>
        </c:ser>
        <c:ser>
          <c:idx val="2"/>
          <c:order val="2"/>
          <c:tx>
            <c:strRef>
              <c:f>Sheet1!$E$2</c:f>
              <c:strCache>
                <c:ptCount val="1"/>
                <c:pt idx="0">
                  <c:v>T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3:$I$6</c:f>
                <c:numCache>
                  <c:formatCode>General</c:formatCode>
                  <c:ptCount val="4"/>
                  <c:pt idx="0">
                    <c:v>3.0745944999999999</c:v>
                  </c:pt>
                  <c:pt idx="1">
                    <c:v>8.6581080000000004</c:v>
                  </c:pt>
                  <c:pt idx="2">
                    <c:v>6.0507779729729698</c:v>
                  </c:pt>
                  <c:pt idx="3">
                    <c:v>6.3291221621621601</c:v>
                  </c:pt>
                </c:numCache>
              </c:numRef>
            </c:plus>
            <c:minus>
              <c:numRef>
                <c:f>Sheet1!$I$3:$I$6</c:f>
                <c:numCache>
                  <c:formatCode>General</c:formatCode>
                  <c:ptCount val="4"/>
                  <c:pt idx="0">
                    <c:v>3.0745944999999999</c:v>
                  </c:pt>
                  <c:pt idx="1">
                    <c:v>8.6581080000000004</c:v>
                  </c:pt>
                  <c:pt idx="2">
                    <c:v>6.0507779729729698</c:v>
                  </c:pt>
                  <c:pt idx="3">
                    <c:v>6.3291221621621601</c:v>
                  </c:pt>
                </c:numCache>
              </c:numRef>
            </c:minus>
          </c:errBars>
          <c:cat>
            <c:strRef>
              <c:f>Sheet1!$B$3:$B$6</c:f>
              <c:strCache>
                <c:ptCount val="4"/>
                <c:pt idx="0">
                  <c:v>WP5</c:v>
                </c:pt>
                <c:pt idx="1">
                  <c:v>Wp2.5</c:v>
                </c:pt>
                <c:pt idx="2">
                  <c:v>WP1.25</c:v>
                </c:pt>
                <c:pt idx="3">
                  <c:v>WP0.625</c:v>
                </c:pt>
              </c:strCache>
            </c:strRef>
          </c:cat>
          <c:val>
            <c:numRef>
              <c:f>Sheet1!$E$3:$E$6</c:f>
              <c:numCache>
                <c:formatCode>General</c:formatCode>
                <c:ptCount val="4"/>
                <c:pt idx="0">
                  <c:v>-11.006864988558354</c:v>
                </c:pt>
                <c:pt idx="1">
                  <c:v>-13.386727688787186</c:v>
                </c:pt>
                <c:pt idx="2">
                  <c:v>65.217391304347828</c:v>
                </c:pt>
                <c:pt idx="3">
                  <c:v>83.2951945080091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1281336"/>
        <c:axId val="191281728"/>
      </c:barChart>
      <c:catAx>
        <c:axId val="19128133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25400">
            <a:solidFill>
              <a:schemeClr val="tx1"/>
            </a:solidFill>
          </a:ln>
        </c:spPr>
        <c:crossAx val="191281728"/>
        <c:crosses val="autoZero"/>
        <c:auto val="1"/>
        <c:lblAlgn val="ctr"/>
        <c:lblOffset val="100"/>
        <c:noMultiLvlLbl val="0"/>
      </c:catAx>
      <c:valAx>
        <c:axId val="19128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1281336"/>
        <c:crosses val="autoZero"/>
        <c:crossBetween val="between"/>
        <c:majorUnit val="30"/>
      </c:valAx>
      <c:spPr>
        <a:ln w="3810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4:$C$17</c:f>
                <c:numCache>
                  <c:formatCode>General</c:formatCode>
                  <c:ptCount val="4"/>
                  <c:pt idx="0">
                    <c:v>8.3000000000000007</c:v>
                  </c:pt>
                  <c:pt idx="1">
                    <c:v>6.7</c:v>
                  </c:pt>
                  <c:pt idx="2">
                    <c:v>7.2</c:v>
                  </c:pt>
                  <c:pt idx="3">
                    <c:v>5.8</c:v>
                  </c:pt>
                </c:numCache>
              </c:numRef>
            </c:plus>
            <c:minus>
              <c:numRef>
                <c:f>Sheet1!$C$14:$C$17</c:f>
                <c:numCache>
                  <c:formatCode>General</c:formatCode>
                  <c:ptCount val="4"/>
                  <c:pt idx="0">
                    <c:v>8.3000000000000007</c:v>
                  </c:pt>
                  <c:pt idx="1">
                    <c:v>6.7</c:v>
                  </c:pt>
                  <c:pt idx="2">
                    <c:v>7.2</c:v>
                  </c:pt>
                  <c:pt idx="3">
                    <c:v>5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4:$A$17</c:f>
              <c:strCache>
                <c:ptCount val="4"/>
                <c:pt idx="0">
                  <c:v>Rottlerin 25</c:v>
                </c:pt>
                <c:pt idx="1">
                  <c:v>Rottlerin 12.5</c:v>
                </c:pt>
                <c:pt idx="2">
                  <c:v>Rottlerin 6.25</c:v>
                </c:pt>
                <c:pt idx="3">
                  <c:v>Rottlerin 3.125</c:v>
                </c:pt>
              </c:strCache>
            </c:strRef>
          </c:cat>
          <c:val>
            <c:numRef>
              <c:f>Sheet1!$B$14:$B$17</c:f>
              <c:numCache>
                <c:formatCode>General</c:formatCode>
                <c:ptCount val="4"/>
                <c:pt idx="0">
                  <c:v>64.730419999999995</c:v>
                </c:pt>
                <c:pt idx="1">
                  <c:v>83.873902000000001</c:v>
                </c:pt>
                <c:pt idx="2">
                  <c:v>96.652317999999994</c:v>
                </c:pt>
                <c:pt idx="3">
                  <c:v>93.526297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402072"/>
        <c:axId val="148535424"/>
      </c:barChart>
      <c:catAx>
        <c:axId val="117402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535424"/>
        <c:crosses val="autoZero"/>
        <c:auto val="1"/>
        <c:lblAlgn val="ctr"/>
        <c:lblOffset val="100"/>
        <c:noMultiLvlLbl val="0"/>
      </c:catAx>
      <c:valAx>
        <c:axId val="14853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7402072"/>
        <c:crosses val="autoZero"/>
        <c:crossBetween val="between"/>
      </c:valAx>
      <c:spPr>
        <a:noFill/>
        <a:ln w="381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2)'!$C$19:$C$22</c:f>
                <c:numCache>
                  <c:formatCode>General</c:formatCode>
                  <c:ptCount val="4"/>
                  <c:pt idx="0">
                    <c:v>5.9</c:v>
                  </c:pt>
                  <c:pt idx="1">
                    <c:v>9.3000000000000007</c:v>
                  </c:pt>
                  <c:pt idx="2">
                    <c:v>6.2</c:v>
                  </c:pt>
                  <c:pt idx="3">
                    <c:v>4.8</c:v>
                  </c:pt>
                </c:numCache>
              </c:numRef>
            </c:plus>
            <c:minus>
              <c:numRef>
                <c:f>'Sheet1 (2)'!$C$19:$C$22</c:f>
                <c:numCache>
                  <c:formatCode>General</c:formatCode>
                  <c:ptCount val="4"/>
                  <c:pt idx="0">
                    <c:v>5.9</c:v>
                  </c:pt>
                  <c:pt idx="1">
                    <c:v>9.3000000000000007</c:v>
                  </c:pt>
                  <c:pt idx="2">
                    <c:v>6.2</c:v>
                  </c:pt>
                  <c:pt idx="3">
                    <c:v>4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2)'!$A$19:$A$22</c:f>
              <c:strCache>
                <c:ptCount val="4"/>
                <c:pt idx="0">
                  <c:v>WP1066 5</c:v>
                </c:pt>
                <c:pt idx="1">
                  <c:v>WP1066 2.5</c:v>
                </c:pt>
                <c:pt idx="2">
                  <c:v>WP1066 1.25</c:v>
                </c:pt>
                <c:pt idx="3">
                  <c:v>WP1066 0.625</c:v>
                </c:pt>
              </c:strCache>
            </c:strRef>
          </c:cat>
          <c:val>
            <c:numRef>
              <c:f>'Sheet1 (2)'!$B$19:$B$22</c:f>
              <c:numCache>
                <c:formatCode>General</c:formatCode>
                <c:ptCount val="4"/>
                <c:pt idx="0">
                  <c:v>62.883220000000001</c:v>
                </c:pt>
                <c:pt idx="1">
                  <c:v>78.757198000000002</c:v>
                </c:pt>
                <c:pt idx="2">
                  <c:v>92.048028000000002</c:v>
                </c:pt>
                <c:pt idx="3">
                  <c:v>95.0263280000000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8535816"/>
        <c:axId val="187307640"/>
      </c:barChart>
      <c:catAx>
        <c:axId val="148535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307640"/>
        <c:crosses val="autoZero"/>
        <c:auto val="1"/>
        <c:lblAlgn val="ctr"/>
        <c:lblOffset val="100"/>
        <c:noMultiLvlLbl val="0"/>
      </c:catAx>
      <c:valAx>
        <c:axId val="187307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8535816"/>
        <c:crosses val="autoZero"/>
        <c:crossBetween val="between"/>
      </c:valAx>
      <c:spPr>
        <a:noFill/>
        <a:ln w="381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45429"/>
            <a:ext cx="7772400" cy="41385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243533"/>
            <a:ext cx="6858000" cy="286998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759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450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32883"/>
            <a:ext cx="1971675" cy="100738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32883"/>
            <a:ext cx="5800725" cy="1007385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42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380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963549"/>
            <a:ext cx="7886700" cy="494474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955072"/>
            <a:ext cx="7886700" cy="26003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42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164417"/>
            <a:ext cx="3886200" cy="75423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164417"/>
            <a:ext cx="3886200" cy="75423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43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32886"/>
            <a:ext cx="7886700" cy="229764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14016"/>
            <a:ext cx="3868340" cy="14281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342130"/>
            <a:ext cx="3868340" cy="63866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14016"/>
            <a:ext cx="3887391" cy="14281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342130"/>
            <a:ext cx="3887391" cy="638661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498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436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6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92480"/>
            <a:ext cx="2949178" cy="27736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11539"/>
            <a:ext cx="4629150" cy="844761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566160"/>
            <a:ext cx="2949178" cy="66067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342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92480"/>
            <a:ext cx="2949178" cy="27736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11539"/>
            <a:ext cx="4629150" cy="844761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566160"/>
            <a:ext cx="2949178" cy="66067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596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32886"/>
            <a:ext cx="7886700" cy="22976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164417"/>
            <a:ext cx="7886700" cy="7542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017676"/>
            <a:ext cx="20574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07C1C-1A27-404C-B04E-E037830D6544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017676"/>
            <a:ext cx="30861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017676"/>
            <a:ext cx="20574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ADE662-B106-4836-9A65-BF010B460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082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76200" y="228600"/>
            <a:ext cx="8915400" cy="4982528"/>
            <a:chOff x="76200" y="228600"/>
            <a:chExt cx="8915400" cy="4982528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5675129"/>
                </p:ext>
              </p:extLst>
            </p:nvPr>
          </p:nvGraphicFramePr>
          <p:xfrm>
            <a:off x="457200" y="690265"/>
            <a:ext cx="4038600" cy="381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Right Triangle 5"/>
            <p:cNvSpPr/>
            <p:nvPr/>
          </p:nvSpPr>
          <p:spPr>
            <a:xfrm>
              <a:off x="1219200" y="4500265"/>
              <a:ext cx="3124200" cy="304800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305848" y="4805065"/>
              <a:ext cx="30700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      12.5      6.25     3.125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76200" y="4539734"/>
              <a:ext cx="1133644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ottlerin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lang="en-US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1852255" y="2491143"/>
              <a:ext cx="46233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 HIV reactivation </a:t>
              </a:r>
            </a:p>
          </p:txBody>
        </p:sp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24040485"/>
                </p:ext>
              </p:extLst>
            </p:nvPr>
          </p:nvGraphicFramePr>
          <p:xfrm>
            <a:off x="4964623" y="690265"/>
            <a:ext cx="4026977" cy="381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" name="Right Triangle 10"/>
            <p:cNvSpPr/>
            <p:nvPr/>
          </p:nvSpPr>
          <p:spPr>
            <a:xfrm>
              <a:off x="5802823" y="4500265"/>
              <a:ext cx="3124200" cy="304800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868217" y="4841796"/>
              <a:ext cx="30059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         2.5      1.25     0.625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685427" y="4539734"/>
              <a:ext cx="1193596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WP 1066 </a:t>
              </a:r>
            </a:p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2633475" y="2491144"/>
              <a:ext cx="46233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 HIV reactivation 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5332" y="228600"/>
              <a:ext cx="6126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61628" y="228600"/>
              <a:ext cx="6126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7831564" y="1524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55170" y="6999890"/>
            <a:ext cx="8883878" cy="3966865"/>
            <a:chOff x="91628" y="1219200"/>
            <a:chExt cx="8693327" cy="3966865"/>
          </a:xfrm>
        </p:grpSpPr>
        <p:graphicFrame>
          <p:nvGraphicFramePr>
            <p:cNvPr id="19" name="Chart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5083807"/>
                </p:ext>
              </p:extLst>
            </p:nvPr>
          </p:nvGraphicFramePr>
          <p:xfrm>
            <a:off x="533400" y="1219200"/>
            <a:ext cx="3993605" cy="335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0" name="Chart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60841322"/>
                </p:ext>
              </p:extLst>
            </p:nvPr>
          </p:nvGraphicFramePr>
          <p:xfrm>
            <a:off x="4981978" y="1219200"/>
            <a:ext cx="3802977" cy="335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3" name="Rectangle 22"/>
            <p:cNvSpPr/>
            <p:nvPr/>
          </p:nvSpPr>
          <p:spPr>
            <a:xfrm>
              <a:off x="91628" y="4539734"/>
              <a:ext cx="1133644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ottlerin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lang="en-US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4654572" y="4539734"/>
              <a:ext cx="1193596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WP 1066 </a:t>
              </a:r>
            </a:p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b="1" dirty="0" err="1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-1089877" y="2746305"/>
              <a:ext cx="284488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ability (%DMSO)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3384624" y="2714773"/>
              <a:ext cx="284488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ability (%DMSO)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213139" y="6419194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835200" y="6450724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ight Triangle 30"/>
          <p:cNvSpPr/>
          <p:nvPr/>
        </p:nvSpPr>
        <p:spPr>
          <a:xfrm>
            <a:off x="1277004" y="10312499"/>
            <a:ext cx="3124200" cy="304800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1363652" y="10617299"/>
            <a:ext cx="3070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25       12.5      6.25     3.12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ight Triangle 32"/>
          <p:cNvSpPr/>
          <p:nvPr/>
        </p:nvSpPr>
        <p:spPr>
          <a:xfrm>
            <a:off x="5844861" y="10296733"/>
            <a:ext cx="3124200" cy="304800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5910255" y="10638264"/>
            <a:ext cx="3005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5          2.5      1.25     0.62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313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62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yavooLab</dc:creator>
  <cp:lastModifiedBy>AyyavooLab</cp:lastModifiedBy>
  <cp:revision>2</cp:revision>
  <dcterms:created xsi:type="dcterms:W3CDTF">2015-09-07T18:09:47Z</dcterms:created>
  <dcterms:modified xsi:type="dcterms:W3CDTF">2015-09-07T18:20:22Z</dcterms:modified>
</cp:coreProperties>
</file>